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0D398201-849D-4432-B3AB-178F9A433387}" v="1" dt="2025-08-19T22:41:56.850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>
        <p:scale>
          <a:sx n="150" d="100"/>
          <a:sy n="150" d="100"/>
        </p:scale>
        <p:origin x="1590" y="-195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Grant, Maria Bartolomeo (Campus)" userId="e44be0db-fe05-47e1-8151-59712ae0728f" providerId="ADAL" clId="{0D398201-849D-4432-B3AB-178F9A433387}"/>
    <pc:docChg chg="modSld">
      <pc:chgData name="Grant, Maria Bartolomeo (Campus)" userId="e44be0db-fe05-47e1-8151-59712ae0728f" providerId="ADAL" clId="{0D398201-849D-4432-B3AB-178F9A433387}" dt="2025-08-19T22:41:59.652" v="40" actId="6549"/>
      <pc:docMkLst>
        <pc:docMk/>
      </pc:docMkLst>
      <pc:sldChg chg="modSp mod">
        <pc:chgData name="Grant, Maria Bartolomeo (Campus)" userId="e44be0db-fe05-47e1-8151-59712ae0728f" providerId="ADAL" clId="{0D398201-849D-4432-B3AB-178F9A433387}" dt="2025-08-19T22:41:59.652" v="40" actId="6549"/>
        <pc:sldMkLst>
          <pc:docMk/>
          <pc:sldMk cId="1546573046" sldId="256"/>
        </pc:sldMkLst>
        <pc:spChg chg="mod">
          <ac:chgData name="Grant, Maria Bartolomeo (Campus)" userId="e44be0db-fe05-47e1-8151-59712ae0728f" providerId="ADAL" clId="{0D398201-849D-4432-B3AB-178F9A433387}" dt="2025-08-19T22:41:59.652" v="40" actId="6549"/>
          <ac:spMkLst>
            <pc:docMk/>
            <pc:sldMk cId="1546573046" sldId="256"/>
            <ac:spMk id="9" creationId="{647AD9A4-FACC-3F8E-A591-991192BF2048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E84EE2-65C8-4570-8CAE-313274F56F89}" type="datetimeFigureOut">
              <a:rPr lang="en-US" smtClean="0"/>
              <a:t>8/30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754455-9438-45D0-AA16-83038C8AD5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58914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E84EE2-65C8-4570-8CAE-313274F56F89}" type="datetimeFigureOut">
              <a:rPr lang="en-US" smtClean="0"/>
              <a:t>8/30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754455-9438-45D0-AA16-83038C8AD5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54879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E84EE2-65C8-4570-8CAE-313274F56F89}" type="datetimeFigureOut">
              <a:rPr lang="en-US" smtClean="0"/>
              <a:t>8/30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754455-9438-45D0-AA16-83038C8AD5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92640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E84EE2-65C8-4570-8CAE-313274F56F89}" type="datetimeFigureOut">
              <a:rPr lang="en-US" smtClean="0"/>
              <a:t>8/30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754455-9438-45D0-AA16-83038C8AD5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2863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E84EE2-65C8-4570-8CAE-313274F56F89}" type="datetimeFigureOut">
              <a:rPr lang="en-US" smtClean="0"/>
              <a:t>8/30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754455-9438-45D0-AA16-83038C8AD5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17499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E84EE2-65C8-4570-8CAE-313274F56F89}" type="datetimeFigureOut">
              <a:rPr lang="en-US" smtClean="0"/>
              <a:t>8/30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754455-9438-45D0-AA16-83038C8AD5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87991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E84EE2-65C8-4570-8CAE-313274F56F89}" type="datetimeFigureOut">
              <a:rPr lang="en-US" smtClean="0"/>
              <a:t>8/30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754455-9438-45D0-AA16-83038C8AD5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20416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E84EE2-65C8-4570-8CAE-313274F56F89}" type="datetimeFigureOut">
              <a:rPr lang="en-US" smtClean="0"/>
              <a:t>8/30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754455-9438-45D0-AA16-83038C8AD5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61722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E84EE2-65C8-4570-8CAE-313274F56F89}" type="datetimeFigureOut">
              <a:rPr lang="en-US" smtClean="0"/>
              <a:t>8/30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754455-9438-45D0-AA16-83038C8AD5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83400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E84EE2-65C8-4570-8CAE-313274F56F89}" type="datetimeFigureOut">
              <a:rPr lang="en-US" smtClean="0"/>
              <a:t>8/30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754455-9438-45D0-AA16-83038C8AD5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78119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E84EE2-65C8-4570-8CAE-313274F56F89}" type="datetimeFigureOut">
              <a:rPr lang="en-US" smtClean="0"/>
              <a:t>8/30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754455-9438-45D0-AA16-83038C8AD5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19770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8E84EE2-65C8-4570-8CAE-313274F56F89}" type="datetimeFigureOut">
              <a:rPr lang="en-US" smtClean="0"/>
              <a:t>8/30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1754455-9438-45D0-AA16-83038C8AD5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06505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>
            <a:extLst>
              <a:ext uri="{FF2B5EF4-FFF2-40B4-BE49-F238E27FC236}">
                <a16:creationId xmlns:a16="http://schemas.microsoft.com/office/drawing/2014/main" id="{5E4ADCCB-7840-92D2-4972-E6F68771A1EE}"/>
              </a:ext>
            </a:extLst>
          </p:cNvPr>
          <p:cNvGrpSpPr/>
          <p:nvPr/>
        </p:nvGrpSpPr>
        <p:grpSpPr>
          <a:xfrm>
            <a:off x="1792527" y="805580"/>
            <a:ext cx="2552700" cy="2223760"/>
            <a:chOff x="1466850" y="742950"/>
            <a:chExt cx="2552700" cy="2223760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16AAB87F-4ADD-04AF-01E2-2E1508FE220C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l="4664" t="6283" r="16276" b="11212"/>
            <a:stretch>
              <a:fillRect/>
            </a:stretch>
          </p:blipFill>
          <p:spPr>
            <a:xfrm>
              <a:off x="1777999" y="742950"/>
              <a:ext cx="2114551" cy="2025650"/>
            </a:xfrm>
            <a:prstGeom prst="rect">
              <a:avLst/>
            </a:prstGeom>
          </p:spPr>
        </p:pic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A644C938-D7A7-823E-5612-B5126DD4F6B7}"/>
                </a:ext>
              </a:extLst>
            </p:cNvPr>
            <p:cNvSpPr txBox="1"/>
            <p:nvPr/>
          </p:nvSpPr>
          <p:spPr>
            <a:xfrm>
              <a:off x="1466850" y="825500"/>
              <a:ext cx="353943" cy="1860550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ctr"/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Cell localization (%)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611961BE-B1E7-1016-86F3-55AA88899632}"/>
                </a:ext>
              </a:extLst>
            </p:cNvPr>
            <p:cNvSpPr txBox="1"/>
            <p:nvPr/>
          </p:nvSpPr>
          <p:spPr>
            <a:xfrm>
              <a:off x="2159000" y="2705100"/>
              <a:ext cx="876300" cy="261610"/>
            </a:xfrm>
            <a:prstGeom prst="rect">
              <a:avLst/>
            </a:prstGeom>
            <a:noFill/>
          </p:spPr>
          <p:txBody>
            <a:bodyPr vert="horz" wrap="square" rtlCol="0">
              <a:spAutoFit/>
            </a:bodyPr>
            <a:lstStyle/>
            <a:p>
              <a:pPr algn="ctr"/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Integrated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81638177-CED3-8E98-67ED-EEEE9ED6DBFF}"/>
                </a:ext>
              </a:extLst>
            </p:cNvPr>
            <p:cNvSpPr txBox="1"/>
            <p:nvPr/>
          </p:nvSpPr>
          <p:spPr>
            <a:xfrm>
              <a:off x="2990850" y="2705100"/>
              <a:ext cx="1028700" cy="261610"/>
            </a:xfrm>
            <a:prstGeom prst="rect">
              <a:avLst/>
            </a:prstGeom>
            <a:noFill/>
          </p:spPr>
          <p:txBody>
            <a:bodyPr vert="horz" wrap="square" rtlCol="0">
              <a:spAutoFit/>
            </a:bodyPr>
            <a:lstStyle/>
            <a:p>
              <a:pPr algn="ctr"/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Perivascular</a:t>
              </a:r>
            </a:p>
          </p:txBody>
        </p:sp>
      </p:grpSp>
      <p:sp>
        <p:nvSpPr>
          <p:cNvPr id="9" name="TextBox 8">
            <a:extLst>
              <a:ext uri="{FF2B5EF4-FFF2-40B4-BE49-F238E27FC236}">
                <a16:creationId xmlns:a16="http://schemas.microsoft.com/office/drawing/2014/main" id="{647AD9A4-FACC-3F8E-A591-991192BF2048}"/>
              </a:ext>
            </a:extLst>
          </p:cNvPr>
          <p:cNvSpPr txBox="1"/>
          <p:nvPr/>
        </p:nvSpPr>
        <p:spPr>
          <a:xfrm>
            <a:off x="394918" y="3408645"/>
            <a:ext cx="5928986" cy="769441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pPr algn="just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en-US" sz="1100" b="1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en-US" sz="1100" b="1" dirty="0"/>
              <a:t>Quantification of vascular integrated and perivascular </a:t>
            </a:r>
            <a:r>
              <a:rPr lang="en-US" sz="1100" b="1"/>
              <a:t>cell localization of iPSC derived cells.</a:t>
            </a:r>
            <a:r>
              <a:rPr lang="en-US" sz="1100"/>
              <a:t> </a:t>
            </a:r>
            <a:r>
              <a:rPr lang="en-US" sz="1100" dirty="0"/>
              <a:t>Image analysis of CD34</a:t>
            </a:r>
            <a:r>
              <a:rPr lang="en-US" sz="1100" baseline="30000" dirty="0"/>
              <a:t>+</a:t>
            </a:r>
            <a:r>
              <a:rPr lang="en-US" sz="1100" dirty="0"/>
              <a:t>/ECFC injected retinas revealed that the majority of injected cells integrated into the blood vessels while a small fraction localized to perivascular regions (Integrated: 27.8% ± 15.5; Perivascular: 3.4% ± 1.5. n=3).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46573046"/>
      </p:ext>
    </p:extLst>
  </p:cSld>
  <p:clrMapOvr>
    <a:masterClrMapping/>
  </p:clrMapOvr>
</p:sld>
</file>

<file path=ppt/theme/theme1.xml><?xml version="1.0" encoding="utf-8"?>
<a:theme xmlns:a="http://schemas.openxmlformats.org/drawingml/2006/main" name="Portriat mode-Ram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Portriat mode-Ram" id="{93FCFA2D-A2F5-4217-8CC2-82A348F57DCC}" vid="{438591CB-3EF2-4226-8A9C-69486D243BA3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Default Theme</Template>
  <TotalTime>3</TotalTime>
  <Words>69</Words>
  <Application>Microsoft Office PowerPoint</Application>
  <PresentationFormat>Letter Paper (8.5x11 in)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Portriat mode-Ram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Prasad, Ram (Campus)</dc:creator>
  <cp:lastModifiedBy>MDPI</cp:lastModifiedBy>
  <cp:revision>3</cp:revision>
  <dcterms:created xsi:type="dcterms:W3CDTF">2025-08-18T22:33:21Z</dcterms:created>
  <dcterms:modified xsi:type="dcterms:W3CDTF">2025-08-30T08:06:2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ae7542bc-63e5-412b-b0a0-d9586028a7d0_Enabled">
    <vt:lpwstr>true</vt:lpwstr>
  </property>
  <property fmtid="{D5CDD505-2E9C-101B-9397-08002B2CF9AE}" pid="3" name="MSIP_Label_ae7542bc-63e5-412b-b0a0-d9586028a7d0_SetDate">
    <vt:lpwstr>2025-08-18T22:39:14Z</vt:lpwstr>
  </property>
  <property fmtid="{D5CDD505-2E9C-101B-9397-08002B2CF9AE}" pid="4" name="MSIP_Label_ae7542bc-63e5-412b-b0a0-d9586028a7d0_Method">
    <vt:lpwstr>Standard</vt:lpwstr>
  </property>
  <property fmtid="{D5CDD505-2E9C-101B-9397-08002B2CF9AE}" pid="5" name="MSIP_Label_ae7542bc-63e5-412b-b0a0-d9586028a7d0_Name">
    <vt:lpwstr>Sensitive</vt:lpwstr>
  </property>
  <property fmtid="{D5CDD505-2E9C-101B-9397-08002B2CF9AE}" pid="6" name="MSIP_Label_ae7542bc-63e5-412b-b0a0-d9586028a7d0_SiteId">
    <vt:lpwstr>d8999fe4-76af-40b3-b435-1d8977abc08c</vt:lpwstr>
  </property>
  <property fmtid="{D5CDD505-2E9C-101B-9397-08002B2CF9AE}" pid="7" name="MSIP_Label_ae7542bc-63e5-412b-b0a0-d9586028a7d0_ActionId">
    <vt:lpwstr>510bf476-fbda-460f-8b7c-2260bf4fbfcb</vt:lpwstr>
  </property>
  <property fmtid="{D5CDD505-2E9C-101B-9397-08002B2CF9AE}" pid="8" name="MSIP_Label_ae7542bc-63e5-412b-b0a0-d9586028a7d0_ContentBits">
    <vt:lpwstr>0</vt:lpwstr>
  </property>
  <property fmtid="{D5CDD505-2E9C-101B-9397-08002B2CF9AE}" pid="9" name="MSIP_Label_ae7542bc-63e5-412b-b0a0-d9586028a7d0_Tag">
    <vt:lpwstr>10, 3, 0, 1</vt:lpwstr>
  </property>
</Properties>
</file>